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74" r:id="rId2"/>
    <p:sldId id="258" r:id="rId3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486" autoAdjust="0"/>
  </p:normalViewPr>
  <p:slideViewPr>
    <p:cSldViewPr snapToGrid="0" showGuides="1">
      <p:cViewPr varScale="1">
        <p:scale>
          <a:sx n="102" d="100"/>
          <a:sy n="102" d="100"/>
        </p:scale>
        <p:origin x="188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6FD8AE-6A2A-42EA-BC93-6DC8DC38B78E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D18FE3-2113-4222-AF46-E0408ABCFF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753284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9D275A-132A-4469-9AA5-5ACEF0A69101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240066-FBCE-417E-8294-E74AED8B91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707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690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160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466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3233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5032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7139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3320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553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6609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5215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527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6A8241-A187-4CFC-AB55-EE408663B968}" type="datetimeFigureOut">
              <a:rPr lang="en-GB" smtClean="0"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94912-2A28-4B5B-9696-ABC951E55E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211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0"/>
          <a:stretch/>
        </p:blipFill>
        <p:spPr bwMode="auto">
          <a:xfrm>
            <a:off x="619125" y="931590"/>
            <a:ext cx="8278688" cy="4759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 rot="16200000">
            <a:off x="-314386" y="1700568"/>
            <a:ext cx="15943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Comic Sans MS" panose="030F0702030302020204" pitchFamily="66" charset="0"/>
              </a:rPr>
              <a:t>JI281 x JI399</a:t>
            </a:r>
          </a:p>
        </p:txBody>
      </p:sp>
      <p:sp>
        <p:nvSpPr>
          <p:cNvPr id="6" name="Rectangle 5"/>
          <p:cNvSpPr/>
          <p:nvPr/>
        </p:nvSpPr>
        <p:spPr>
          <a:xfrm rot="16200000">
            <a:off x="-189821" y="3467572"/>
            <a:ext cx="13452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sz="1400" dirty="0">
                <a:solidFill>
                  <a:prstClr val="black"/>
                </a:solidFill>
                <a:latin typeface="Comic Sans MS" panose="030F0702030302020204" pitchFamily="66" charset="0"/>
              </a:rPr>
              <a:t>JI15 x JI399</a:t>
            </a:r>
          </a:p>
        </p:txBody>
      </p:sp>
      <p:sp>
        <p:nvSpPr>
          <p:cNvPr id="7" name="Rectangle 6"/>
          <p:cNvSpPr/>
          <p:nvPr/>
        </p:nvSpPr>
        <p:spPr>
          <a:xfrm rot="16200000">
            <a:off x="-215470" y="4838460"/>
            <a:ext cx="13965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sz="1400" dirty="0">
                <a:solidFill>
                  <a:prstClr val="black"/>
                </a:solidFill>
                <a:latin typeface="Comic Sans MS" panose="030F0702030302020204" pitchFamily="66" charset="0"/>
              </a:rPr>
              <a:t>JI15 x JI1194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85019" y="354675"/>
            <a:ext cx="4682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556412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912"/>
          <a:stretch/>
        </p:blipFill>
        <p:spPr bwMode="auto">
          <a:xfrm>
            <a:off x="79102" y="733425"/>
            <a:ext cx="9064898" cy="1279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39551" y="5257562"/>
            <a:ext cx="91440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GB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Example NMR traces derived for seeds of three populations of RILs (year 2 data; three traces for each of JI 281 x JI 399 and JI 15 x JI 1194 RILs, two for JI 15 x JI 399). </a:t>
            </a:r>
            <a:r>
              <a:rPr lang="en-GB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Heat maps generated from normalised binned NMR data (10 to 0 ppm from left to right) and Mean of Absolute Deviation from the mean (MAD) values derived for seeds from three populations of RILs (JI 281 x JI 399, JI 15 x JI 1194 RILs, JI 15 x JI 399, Y2), with data for two locations (JIC, PGRO) shown for </a:t>
            </a:r>
            <a:r>
              <a:rPr lang="en-GB" sz="140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o populations. </a:t>
            </a:r>
            <a:r>
              <a:rPr lang="en-GB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Example of the correlation between the smallest </a:t>
            </a:r>
            <a:r>
              <a:rPr lang="en-GB" sz="14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 in a bin and MAD value determined for the same bins in the analysis of JI 15 x JI 399 RILs, mature seed, year 1, JIC location. </a:t>
            </a:r>
            <a:r>
              <a:rPr lang="en-GB" sz="14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4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 range 0 – 0.07; ii) expanded scale for </a:t>
            </a:r>
            <a:r>
              <a:rPr lang="en-GB" sz="14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 range 0 – 0.005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DD6D94B-38AC-49B0-AB50-7D7B5E17C90A}"/>
              </a:ext>
            </a:extLst>
          </p:cNvPr>
          <p:cNvSpPr/>
          <p:nvPr/>
        </p:nvSpPr>
        <p:spPr>
          <a:xfrm>
            <a:off x="336442" y="224909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8238FFF-C28B-4318-840B-490EE71A8E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7641" y="2518520"/>
            <a:ext cx="5733260" cy="267323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CF064C0E-C927-4149-9BBB-91157121532D}"/>
              </a:ext>
            </a:extLst>
          </p:cNvPr>
          <p:cNvSpPr/>
          <p:nvPr/>
        </p:nvSpPr>
        <p:spPr>
          <a:xfrm>
            <a:off x="344458" y="2518520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25237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29</TotalTime>
  <Words>199</Words>
  <Application>Microsoft Office PowerPoint</Application>
  <PresentationFormat>On-screen Show (4:3)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omic Sans MS</vt:lpstr>
      <vt:lpstr>Times New Roman</vt:lpstr>
      <vt:lpstr>Office Theme</vt:lpstr>
      <vt:lpstr>PowerPoint Presentation</vt:lpstr>
      <vt:lpstr>PowerPoint Presentation</vt:lpstr>
    </vt:vector>
  </TitlesOfParts>
  <Company>NB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e Hattori (JIC)</dc:creator>
  <cp:lastModifiedBy>claire domoney (JIC)</cp:lastModifiedBy>
  <cp:revision>45</cp:revision>
  <cp:lastPrinted>2016-10-26T13:12:03Z</cp:lastPrinted>
  <dcterms:created xsi:type="dcterms:W3CDTF">2014-08-13T11:34:12Z</dcterms:created>
  <dcterms:modified xsi:type="dcterms:W3CDTF">2018-02-26T11:06:32Z</dcterms:modified>
</cp:coreProperties>
</file>